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380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12518B-18E1-4995-8360-D5DB8730B2B3}" type="datetimeFigureOut">
              <a:rPr lang="en-GB" smtClean="0"/>
              <a:t>23/12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EE966B-0280-4C46-8E11-AB2772166B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88947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12518B-18E1-4995-8360-D5DB8730B2B3}" type="datetimeFigureOut">
              <a:rPr lang="en-GB" smtClean="0"/>
              <a:t>23/12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EE966B-0280-4C46-8E11-AB2772166B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74453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12518B-18E1-4995-8360-D5DB8730B2B3}" type="datetimeFigureOut">
              <a:rPr lang="en-GB" smtClean="0"/>
              <a:t>23/12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EE966B-0280-4C46-8E11-AB2772166B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40377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12518B-18E1-4995-8360-D5DB8730B2B3}" type="datetimeFigureOut">
              <a:rPr lang="en-GB" smtClean="0"/>
              <a:t>23/12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EE966B-0280-4C46-8E11-AB2772166B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01282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12518B-18E1-4995-8360-D5DB8730B2B3}" type="datetimeFigureOut">
              <a:rPr lang="en-GB" smtClean="0"/>
              <a:t>23/12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EE966B-0280-4C46-8E11-AB2772166B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67366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12518B-18E1-4995-8360-D5DB8730B2B3}" type="datetimeFigureOut">
              <a:rPr lang="en-GB" smtClean="0"/>
              <a:t>23/12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EE966B-0280-4C46-8E11-AB2772166B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61993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12518B-18E1-4995-8360-D5DB8730B2B3}" type="datetimeFigureOut">
              <a:rPr lang="en-GB" smtClean="0"/>
              <a:t>23/12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EE966B-0280-4C46-8E11-AB2772166B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321007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12518B-18E1-4995-8360-D5DB8730B2B3}" type="datetimeFigureOut">
              <a:rPr lang="en-GB" smtClean="0"/>
              <a:t>23/12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EE966B-0280-4C46-8E11-AB2772166B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48367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12518B-18E1-4995-8360-D5DB8730B2B3}" type="datetimeFigureOut">
              <a:rPr lang="en-GB" smtClean="0"/>
              <a:t>23/12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EE966B-0280-4C46-8E11-AB2772166B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04140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12518B-18E1-4995-8360-D5DB8730B2B3}" type="datetimeFigureOut">
              <a:rPr lang="en-GB" smtClean="0"/>
              <a:t>23/12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EE966B-0280-4C46-8E11-AB2772166B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40431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12518B-18E1-4995-8360-D5DB8730B2B3}" type="datetimeFigureOut">
              <a:rPr lang="en-GB" smtClean="0"/>
              <a:t>23/12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EE966B-0280-4C46-8E11-AB2772166B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55741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12518B-18E1-4995-8360-D5DB8730B2B3}" type="datetimeFigureOut">
              <a:rPr lang="en-GB" smtClean="0"/>
              <a:t>23/12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EE966B-0280-4C46-8E11-AB2772166B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12574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Multimedia </a:t>
            </a:r>
            <a:r>
              <a:rPr lang="en-US" smtClean="0"/>
              <a:t>Appendix </a:t>
            </a:r>
            <a:r>
              <a:rPr lang="en-US" smtClean="0"/>
              <a:t>2</a:t>
            </a:r>
            <a:endParaRPr lang="en-GB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 smtClean="0"/>
              <a:t>Online </a:t>
            </a:r>
            <a:r>
              <a:rPr lang="en-US" dirty="0" smtClean="0"/>
              <a:t>SMS Text-Messaging </a:t>
            </a:r>
            <a:r>
              <a:rPr lang="en-US" dirty="0" smtClean="0"/>
              <a:t>Too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8456579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Participant Details</a:t>
            </a:r>
            <a:endParaRPr lang="en-GB" dirty="0"/>
          </a:p>
        </p:txBody>
      </p:sp>
      <p:pic>
        <p:nvPicPr>
          <p:cNvPr id="1026" name="Picture 2" descr="C:\Users\Andre\Google Drive\Research\Papers &amp; Conferences_Seminars\Scientific Papers\2015_Paper 2_PhD\JMIR\Submission\Multimedia Appendix 1_SMStool1.png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2133600"/>
            <a:ext cx="8458200" cy="340355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686125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cheduling Text Messages</a:t>
            </a:r>
            <a:endParaRPr lang="en-GB" dirty="0"/>
          </a:p>
        </p:txBody>
      </p:sp>
      <p:pic>
        <p:nvPicPr>
          <p:cNvPr id="2050" name="Picture 2" descr="C:\Users\Andre\Google Drive\Research\Papers &amp; Conferences_Seminars\Scientific Papers\2015_Paper 2_PhD\JMIR\Submission\Multimedia Appendix 1_SMStool2.png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8453" y="1828800"/>
            <a:ext cx="8606592" cy="389801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2884986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hecking Status (delivery)</a:t>
            </a:r>
            <a:endParaRPr lang="en-GB" dirty="0"/>
          </a:p>
        </p:txBody>
      </p:sp>
      <p:pic>
        <p:nvPicPr>
          <p:cNvPr id="3074" name="Picture 2" descr="C:\Users\Andre\Google Drive\Research\Papers &amp; Conferences_Seminars\Scientific Papers\2015_Paper 2_PhD\JMIR\Submission\Multimedia Appendix 1_SMStool3.png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600" y="2438400"/>
            <a:ext cx="8632307" cy="27225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933490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17</Words>
  <Application>Microsoft Office PowerPoint</Application>
  <PresentationFormat>On-screen Show (4:3)</PresentationFormat>
  <Paragraphs>5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Multimedia Appendix 2</vt:lpstr>
      <vt:lpstr>Participant Details</vt:lpstr>
      <vt:lpstr>Scheduling Text Messages</vt:lpstr>
      <vt:lpstr>Checking Status (delivery)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ultimedia Appendix 1</dc:title>
  <dc:creator>Andre</dc:creator>
  <cp:lastModifiedBy>Andre</cp:lastModifiedBy>
  <cp:revision>4</cp:revision>
  <dcterms:created xsi:type="dcterms:W3CDTF">2015-10-13T06:05:56Z</dcterms:created>
  <dcterms:modified xsi:type="dcterms:W3CDTF">2015-12-23T04:33:42Z</dcterms:modified>
</cp:coreProperties>
</file>